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133207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35"/>
    <p:restoredTop sz="96327"/>
  </p:normalViewPr>
  <p:slideViewPr>
    <p:cSldViewPr snapToGrid="0">
      <p:cViewPr varScale="1">
        <p:scale>
          <a:sx n="177" d="100"/>
          <a:sy n="177" d="100"/>
        </p:scale>
        <p:origin x="184" y="4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65089" y="1122363"/>
            <a:ext cx="9990535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3602038"/>
            <a:ext cx="9990535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398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0527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5" y="365125"/>
            <a:ext cx="2872279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799" y="365125"/>
            <a:ext cx="8450327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2204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3682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1" y="1709739"/>
            <a:ext cx="1148911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1" y="4589464"/>
            <a:ext cx="1148911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1022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1825625"/>
            <a:ext cx="5661303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1825625"/>
            <a:ext cx="5661303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043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365126"/>
            <a:ext cx="1148911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5" y="1681163"/>
            <a:ext cx="563528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5" y="2505075"/>
            <a:ext cx="5635285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1" y="1681163"/>
            <a:ext cx="566303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1" y="2505075"/>
            <a:ext cx="566303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121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0058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705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457200"/>
            <a:ext cx="429627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987426"/>
            <a:ext cx="674361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057400"/>
            <a:ext cx="429627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67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457200"/>
            <a:ext cx="429627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987426"/>
            <a:ext cx="674361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057400"/>
            <a:ext cx="429627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144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365126"/>
            <a:ext cx="1148911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1825625"/>
            <a:ext cx="1148911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6356351"/>
            <a:ext cx="299716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93EAE9-C3BB-5C40-8EFF-624BD1B5DD64}" type="datetimeFigureOut">
              <a:rPr kumimoji="1" lang="ja-JP" altLang="en-US" smtClean="0"/>
              <a:t>2023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6356351"/>
            <a:ext cx="449574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6356351"/>
            <a:ext cx="299716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61421-2911-B249-8EEB-2B747496DE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6726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54320423-5BE0-83B3-4C8B-97512DC715DA}"/>
              </a:ext>
            </a:extLst>
          </p:cNvPr>
          <p:cNvCxnSpPr>
            <a:cxnSpLocks/>
          </p:cNvCxnSpPr>
          <p:nvPr/>
        </p:nvCxnSpPr>
        <p:spPr>
          <a:xfrm>
            <a:off x="7760986" y="475273"/>
            <a:ext cx="0" cy="1179498"/>
          </a:xfrm>
          <a:prstGeom prst="line">
            <a:avLst/>
          </a:prstGeom>
          <a:ln w="38100">
            <a:noFill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93" name="グループ化 92">
            <a:extLst>
              <a:ext uri="{FF2B5EF4-FFF2-40B4-BE49-F238E27FC236}">
                <a16:creationId xmlns:a16="http://schemas.microsoft.com/office/drawing/2014/main" id="{D8A8FAA2-5672-7DFB-5966-7A88A375D09C}"/>
              </a:ext>
            </a:extLst>
          </p:cNvPr>
          <p:cNvGrpSpPr/>
          <p:nvPr/>
        </p:nvGrpSpPr>
        <p:grpSpPr>
          <a:xfrm>
            <a:off x="149597" y="11219"/>
            <a:ext cx="4607250" cy="6755318"/>
            <a:chOff x="507407" y="70853"/>
            <a:chExt cx="4607250" cy="6755318"/>
          </a:xfrm>
        </p:grpSpPr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4CCA7F11-4AA9-82E2-2147-E52CF804B8F6}"/>
                </a:ext>
              </a:extLst>
            </p:cNvPr>
            <p:cNvSpPr txBox="1"/>
            <p:nvPr/>
          </p:nvSpPr>
          <p:spPr>
            <a:xfrm>
              <a:off x="1012802" y="1322275"/>
              <a:ext cx="81464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Elf1 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ja-JP" sz="1200" dirty="0">
                  <a:solidFill>
                    <a:schemeClr val="bg1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Ets1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ja-JP" sz="1200" dirty="0">
                  <a:solidFill>
                    <a:schemeClr val="bg1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Runx1</a:t>
              </a: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/2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44939D61-0120-1506-BBD2-19973DC04965}"/>
                </a:ext>
              </a:extLst>
            </p:cNvPr>
            <p:cNvSpPr txBox="1"/>
            <p:nvPr/>
          </p:nvSpPr>
          <p:spPr>
            <a:xfrm>
              <a:off x="4001852" y="3684270"/>
              <a:ext cx="926857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ja-JP" altLang="en-US" sz="120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Mo</a:t>
              </a:r>
              <a:r>
                <a:rPr lang="en-US" altLang="ja-JP" sz="1200" dirty="0" err="1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nocytes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B0D66712-3C0D-BF50-4DDC-8D808A147D60}"/>
                </a:ext>
              </a:extLst>
            </p:cNvPr>
            <p:cNvSpPr txBox="1"/>
            <p:nvPr/>
          </p:nvSpPr>
          <p:spPr>
            <a:xfrm>
              <a:off x="4001852" y="5506066"/>
              <a:ext cx="1112805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ja-JP" altLang="en-US" sz="120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M</a:t>
              </a:r>
              <a:r>
                <a:rPr lang="en-US" altLang="ja-JP" sz="1200" dirty="0" err="1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acrophages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418E5AC5-1CA1-9FC1-7277-4B61D6FB6EDD}"/>
                </a:ext>
              </a:extLst>
            </p:cNvPr>
            <p:cNvSpPr txBox="1"/>
            <p:nvPr/>
          </p:nvSpPr>
          <p:spPr>
            <a:xfrm>
              <a:off x="4001850" y="4595168"/>
              <a:ext cx="1088760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ja-JP" altLang="en-US" sz="120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G</a:t>
              </a:r>
              <a:r>
                <a:rPr lang="en-US" altLang="ja-JP" sz="1200" dirty="0" err="1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ranulocytes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B2C1660F-1FC8-D6D5-4228-6258CE8075B2}"/>
                </a:ext>
              </a:extLst>
            </p:cNvPr>
            <p:cNvSpPr txBox="1"/>
            <p:nvPr/>
          </p:nvSpPr>
          <p:spPr>
            <a:xfrm>
              <a:off x="4001852" y="6416964"/>
              <a:ext cx="1039067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ja-JP" altLang="en-US" sz="120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Ery</a:t>
              </a:r>
              <a:r>
                <a:rPr lang="en-US" altLang="ja-JP" sz="1200" dirty="0" err="1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throcytes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F00D32E3-A0C8-97BE-91B6-5E272F3CEF7C}"/>
                </a:ext>
              </a:extLst>
            </p:cNvPr>
            <p:cNvSpPr txBox="1"/>
            <p:nvPr/>
          </p:nvSpPr>
          <p:spPr>
            <a:xfrm>
              <a:off x="4001852" y="1862474"/>
              <a:ext cx="625941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ja-JP" altLang="en-US" sz="120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T</a:t>
              </a:r>
              <a:r>
                <a:rPr lang="en-US" altLang="ja-JP" sz="1200" dirty="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 cells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D275C26A-E950-1A02-1D30-3864A43530F7}"/>
                </a:ext>
              </a:extLst>
            </p:cNvPr>
            <p:cNvSpPr txBox="1"/>
            <p:nvPr/>
          </p:nvSpPr>
          <p:spPr>
            <a:xfrm>
              <a:off x="4001852" y="2773372"/>
              <a:ext cx="636713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ja-JP" altLang="en-US" sz="120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B</a:t>
              </a:r>
              <a:r>
                <a:rPr lang="en-US" altLang="ja-JP" sz="1200" dirty="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 cells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FD40C5F9-84D4-CFD6-9EE0-39A72AA2A71B}"/>
                </a:ext>
              </a:extLst>
            </p:cNvPr>
            <p:cNvSpPr txBox="1"/>
            <p:nvPr/>
          </p:nvSpPr>
          <p:spPr>
            <a:xfrm>
              <a:off x="4001850" y="951576"/>
              <a:ext cx="747320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ja-JP" altLang="en-US" sz="120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NK</a:t>
              </a:r>
              <a:r>
                <a:rPr lang="en-US" altLang="ja-JP" sz="1200" dirty="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 cells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4A07DC33-3CFA-587C-EF0E-F375FC06A221}"/>
                </a:ext>
              </a:extLst>
            </p:cNvPr>
            <p:cNvSpPr txBox="1"/>
            <p:nvPr/>
          </p:nvSpPr>
          <p:spPr>
            <a:xfrm>
              <a:off x="2221208" y="1322275"/>
              <a:ext cx="70564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ja-JP" sz="1200" dirty="0">
                  <a:solidFill>
                    <a:schemeClr val="bg1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IRF1</a:t>
              </a:r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/2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Foxo1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Elk4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BD633E64-D32A-5B72-0EA8-0B0AAFD1E029}"/>
                </a:ext>
              </a:extLst>
            </p:cNvPr>
            <p:cNvSpPr txBox="1"/>
            <p:nvPr/>
          </p:nvSpPr>
          <p:spPr>
            <a:xfrm>
              <a:off x="3215006" y="70853"/>
              <a:ext cx="681597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bet</a:t>
              </a:r>
              <a:endParaRPr lang="en-US" altLang="ja-JP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omes</a:t>
              </a:r>
              <a:endParaRPr lang="en-US" altLang="ja-JP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Tcf7 12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ef2a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Runx2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BFB12797-23B7-A0A3-0F16-DA6092DBFD0C}"/>
                </a:ext>
              </a:extLst>
            </p:cNvPr>
            <p:cNvSpPr txBox="1"/>
            <p:nvPr/>
          </p:nvSpPr>
          <p:spPr>
            <a:xfrm>
              <a:off x="3215004" y="1932364"/>
              <a:ext cx="646331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Pax5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Ebf1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n-US" altLang="ja-JP" sz="1200" dirty="0" err="1">
                  <a:solidFill>
                    <a:schemeClr val="bg1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SpiB</a:t>
              </a:r>
              <a:endParaRPr lang="en-US" altLang="ja-JP" sz="1200" dirty="0">
                <a:solidFill>
                  <a:schemeClr val="bg1"/>
                </a:solidFill>
                <a:highlight>
                  <a:srgbClr val="000000"/>
                </a:highlight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Oct2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Mef2c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6B816DA5-348F-2F9C-4DDF-E61F13BA57D2}"/>
                </a:ext>
              </a:extLst>
            </p:cNvPr>
            <p:cNvSpPr txBox="1"/>
            <p:nvPr/>
          </p:nvSpPr>
          <p:spPr>
            <a:xfrm>
              <a:off x="3215004" y="3552364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tf3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7ADAD3EB-9A17-7114-9E5C-583397EF327E}"/>
                </a:ext>
              </a:extLst>
            </p:cNvPr>
            <p:cNvSpPr txBox="1"/>
            <p:nvPr/>
          </p:nvSpPr>
          <p:spPr>
            <a:xfrm>
              <a:off x="2456286" y="4299288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ebpb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5C8BC042-AFFE-CD3D-66A8-B4E7651FB50C}"/>
                </a:ext>
              </a:extLst>
            </p:cNvPr>
            <p:cNvSpPr txBox="1"/>
            <p:nvPr/>
          </p:nvSpPr>
          <p:spPr>
            <a:xfrm>
              <a:off x="3215004" y="5385856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Junb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01DF7C0D-0DA1-1278-76F1-59971A63C858}"/>
                </a:ext>
              </a:extLst>
            </p:cNvPr>
            <p:cNvSpPr txBox="1"/>
            <p:nvPr/>
          </p:nvSpPr>
          <p:spPr>
            <a:xfrm>
              <a:off x="3215004" y="5769122"/>
              <a:ext cx="603050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Gata1</a:t>
              </a: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Klf1</a:t>
              </a:r>
            </a:p>
            <a:p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afk</a:t>
              </a:r>
              <a:endParaRPr lang="en-US" altLang="ja-JP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Sox6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DEE3C0E5-6A47-553A-3A0D-944DE49D122D}"/>
                </a:ext>
              </a:extLst>
            </p:cNvPr>
            <p:cNvSpPr txBox="1"/>
            <p:nvPr/>
          </p:nvSpPr>
          <p:spPr>
            <a:xfrm>
              <a:off x="2118156" y="6138454"/>
              <a:ext cx="75052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Gata1/2</a:t>
              </a:r>
            </a:p>
            <a:p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myb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フリーフォーム 61">
              <a:extLst>
                <a:ext uri="{FF2B5EF4-FFF2-40B4-BE49-F238E27FC236}">
                  <a16:creationId xmlns:a16="http://schemas.microsoft.com/office/drawing/2014/main" id="{1D5BB673-EDDD-35E9-A66F-91D070B84943}"/>
                </a:ext>
              </a:extLst>
            </p:cNvPr>
            <p:cNvSpPr/>
            <p:nvPr/>
          </p:nvSpPr>
          <p:spPr>
            <a:xfrm>
              <a:off x="3034758" y="1974540"/>
              <a:ext cx="968997" cy="9515"/>
            </a:xfrm>
            <a:custGeom>
              <a:avLst/>
              <a:gdLst>
                <a:gd name="connsiteX0" fmla="*/ 1751013 w 1751006"/>
                <a:gd name="connsiteY0" fmla="*/ 6 h 9515"/>
                <a:gd name="connsiteX1" fmla="*/ 6 w 1751006"/>
                <a:gd name="connsiteY1" fmla="*/ 6 h 9515"/>
                <a:gd name="connsiteX2" fmla="*/ 6 w 1751006"/>
                <a:gd name="connsiteY2" fmla="*/ 6 h 95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51006" h="9515">
                  <a:moveTo>
                    <a:pt x="1751013" y="6"/>
                  </a:moveTo>
                  <a:lnTo>
                    <a:pt x="6" y="6"/>
                  </a:lnTo>
                  <a:lnTo>
                    <a:pt x="6" y="6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3" name="フリーフォーム 62">
              <a:extLst>
                <a:ext uri="{FF2B5EF4-FFF2-40B4-BE49-F238E27FC236}">
                  <a16:creationId xmlns:a16="http://schemas.microsoft.com/office/drawing/2014/main" id="{57211CB6-4357-8896-2663-336263FD7FAE}"/>
                </a:ext>
              </a:extLst>
            </p:cNvPr>
            <p:cNvSpPr/>
            <p:nvPr/>
          </p:nvSpPr>
          <p:spPr>
            <a:xfrm>
              <a:off x="3034758" y="3810956"/>
              <a:ext cx="968997" cy="918208"/>
            </a:xfrm>
            <a:custGeom>
              <a:avLst/>
              <a:gdLst>
                <a:gd name="connsiteX0" fmla="*/ 1751013 w 1751006"/>
                <a:gd name="connsiteY0" fmla="*/ 6 h 918208"/>
                <a:gd name="connsiteX1" fmla="*/ 6 w 1751006"/>
                <a:gd name="connsiteY1" fmla="*/ 6 h 918208"/>
                <a:gd name="connsiteX2" fmla="*/ 6 w 1751006"/>
                <a:gd name="connsiteY2" fmla="*/ 918214 h 9182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51006" h="918208">
                  <a:moveTo>
                    <a:pt x="1751013" y="6"/>
                  </a:moveTo>
                  <a:lnTo>
                    <a:pt x="6" y="6"/>
                  </a:lnTo>
                  <a:lnTo>
                    <a:pt x="6" y="918214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4" name="フリーフォーム 63">
              <a:extLst>
                <a:ext uri="{FF2B5EF4-FFF2-40B4-BE49-F238E27FC236}">
                  <a16:creationId xmlns:a16="http://schemas.microsoft.com/office/drawing/2014/main" id="{5BC334F7-7A47-E632-F917-5F01648E1A84}"/>
                </a:ext>
              </a:extLst>
            </p:cNvPr>
            <p:cNvSpPr/>
            <p:nvPr/>
          </p:nvSpPr>
          <p:spPr>
            <a:xfrm>
              <a:off x="2065761" y="4729164"/>
              <a:ext cx="968997" cy="918208"/>
            </a:xfrm>
            <a:custGeom>
              <a:avLst/>
              <a:gdLst>
                <a:gd name="connsiteX0" fmla="*/ 1751012 w 1751006"/>
                <a:gd name="connsiteY0" fmla="*/ 6 h 918208"/>
                <a:gd name="connsiteX1" fmla="*/ 6 w 1751006"/>
                <a:gd name="connsiteY1" fmla="*/ 6 h 918208"/>
                <a:gd name="connsiteX2" fmla="*/ 6 w 1751006"/>
                <a:gd name="connsiteY2" fmla="*/ 918214 h 9182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51006" h="918208">
                  <a:moveTo>
                    <a:pt x="1751012" y="6"/>
                  </a:moveTo>
                  <a:lnTo>
                    <a:pt x="6" y="6"/>
                  </a:lnTo>
                  <a:lnTo>
                    <a:pt x="6" y="918214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5" name="フリーフォーム 64">
              <a:extLst>
                <a:ext uri="{FF2B5EF4-FFF2-40B4-BE49-F238E27FC236}">
                  <a16:creationId xmlns:a16="http://schemas.microsoft.com/office/drawing/2014/main" id="{FBA9FFB3-74E1-75AD-7982-C2870B9EB378}"/>
                </a:ext>
              </a:extLst>
            </p:cNvPr>
            <p:cNvSpPr/>
            <p:nvPr/>
          </p:nvSpPr>
          <p:spPr>
            <a:xfrm>
              <a:off x="897932" y="3810956"/>
              <a:ext cx="1167829" cy="1836416"/>
            </a:xfrm>
            <a:custGeom>
              <a:avLst/>
              <a:gdLst>
                <a:gd name="connsiteX0" fmla="*/ 3502015 w 3502009"/>
                <a:gd name="connsiteY0" fmla="*/ 1836422 h 1836416"/>
                <a:gd name="connsiteX1" fmla="*/ 6 w 3502009"/>
                <a:gd name="connsiteY1" fmla="*/ 1836422 h 1836416"/>
                <a:gd name="connsiteX2" fmla="*/ 6 w 3502009"/>
                <a:gd name="connsiteY2" fmla="*/ 6 h 183641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502009" h="1836416">
                  <a:moveTo>
                    <a:pt x="3502015" y="1836422"/>
                  </a:moveTo>
                  <a:lnTo>
                    <a:pt x="6" y="1836422"/>
                  </a:lnTo>
                  <a:lnTo>
                    <a:pt x="6" y="6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6" name="フリーフォーム 65">
              <a:extLst>
                <a:ext uri="{FF2B5EF4-FFF2-40B4-BE49-F238E27FC236}">
                  <a16:creationId xmlns:a16="http://schemas.microsoft.com/office/drawing/2014/main" id="{CCCE455A-20FE-D1AA-5D5E-B8BC9EFAEA9B}"/>
                </a:ext>
              </a:extLst>
            </p:cNvPr>
            <p:cNvSpPr/>
            <p:nvPr/>
          </p:nvSpPr>
          <p:spPr>
            <a:xfrm>
              <a:off x="3034758" y="4729164"/>
              <a:ext cx="968997" cy="9515"/>
            </a:xfrm>
            <a:custGeom>
              <a:avLst/>
              <a:gdLst>
                <a:gd name="connsiteX0" fmla="*/ 1751013 w 1751006"/>
                <a:gd name="connsiteY0" fmla="*/ 6 h 9515"/>
                <a:gd name="connsiteX1" fmla="*/ 6 w 1751006"/>
                <a:gd name="connsiteY1" fmla="*/ 6 h 9515"/>
                <a:gd name="connsiteX2" fmla="*/ 6 w 1751006"/>
                <a:gd name="connsiteY2" fmla="*/ 6 h 95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51006" h="9515">
                  <a:moveTo>
                    <a:pt x="1751013" y="6"/>
                  </a:moveTo>
                  <a:lnTo>
                    <a:pt x="6" y="6"/>
                  </a:lnTo>
                  <a:lnTo>
                    <a:pt x="6" y="6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7" name="フリーフォーム 66">
              <a:extLst>
                <a:ext uri="{FF2B5EF4-FFF2-40B4-BE49-F238E27FC236}">
                  <a16:creationId xmlns:a16="http://schemas.microsoft.com/office/drawing/2014/main" id="{FC442679-EB82-92A7-EDAB-3A37DA4ADF7B}"/>
                </a:ext>
              </a:extLst>
            </p:cNvPr>
            <p:cNvSpPr/>
            <p:nvPr/>
          </p:nvSpPr>
          <p:spPr>
            <a:xfrm>
              <a:off x="3034758" y="1056332"/>
              <a:ext cx="968997" cy="918208"/>
            </a:xfrm>
            <a:custGeom>
              <a:avLst/>
              <a:gdLst>
                <a:gd name="connsiteX0" fmla="*/ 1751013 w 1751006"/>
                <a:gd name="connsiteY0" fmla="*/ 6 h 918208"/>
                <a:gd name="connsiteX1" fmla="*/ 6 w 1751006"/>
                <a:gd name="connsiteY1" fmla="*/ 6 h 918208"/>
                <a:gd name="connsiteX2" fmla="*/ 6 w 1751006"/>
                <a:gd name="connsiteY2" fmla="*/ 918214 h 9182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51006" h="918208">
                  <a:moveTo>
                    <a:pt x="1751013" y="6"/>
                  </a:moveTo>
                  <a:lnTo>
                    <a:pt x="6" y="6"/>
                  </a:lnTo>
                  <a:lnTo>
                    <a:pt x="6" y="918214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8" name="フリーフォーム 67">
              <a:extLst>
                <a:ext uri="{FF2B5EF4-FFF2-40B4-BE49-F238E27FC236}">
                  <a16:creationId xmlns:a16="http://schemas.microsoft.com/office/drawing/2014/main" id="{8AECB568-3D63-CA22-30A6-5466386DD1FF}"/>
                </a:ext>
              </a:extLst>
            </p:cNvPr>
            <p:cNvSpPr/>
            <p:nvPr/>
          </p:nvSpPr>
          <p:spPr>
            <a:xfrm>
              <a:off x="3034758" y="1974540"/>
              <a:ext cx="968997" cy="918208"/>
            </a:xfrm>
            <a:custGeom>
              <a:avLst/>
              <a:gdLst>
                <a:gd name="connsiteX0" fmla="*/ 1751013 w 1751006"/>
                <a:gd name="connsiteY0" fmla="*/ 918214 h 918208"/>
                <a:gd name="connsiteX1" fmla="*/ 6 w 1751006"/>
                <a:gd name="connsiteY1" fmla="*/ 918214 h 918208"/>
                <a:gd name="connsiteX2" fmla="*/ 6 w 1751006"/>
                <a:gd name="connsiteY2" fmla="*/ 6 h 9182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51006" h="918208">
                  <a:moveTo>
                    <a:pt x="1751013" y="918214"/>
                  </a:moveTo>
                  <a:lnTo>
                    <a:pt x="6" y="918214"/>
                  </a:lnTo>
                  <a:lnTo>
                    <a:pt x="6" y="6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69" name="フリーフォーム 68">
              <a:extLst>
                <a:ext uri="{FF2B5EF4-FFF2-40B4-BE49-F238E27FC236}">
                  <a16:creationId xmlns:a16="http://schemas.microsoft.com/office/drawing/2014/main" id="{7869C6E9-ECD8-9997-BAD7-2EE5158FEEAF}"/>
                </a:ext>
              </a:extLst>
            </p:cNvPr>
            <p:cNvSpPr/>
            <p:nvPr/>
          </p:nvSpPr>
          <p:spPr>
            <a:xfrm>
              <a:off x="897934" y="1974540"/>
              <a:ext cx="2136824" cy="1836416"/>
            </a:xfrm>
            <a:custGeom>
              <a:avLst/>
              <a:gdLst>
                <a:gd name="connsiteX0" fmla="*/ 5253022 w 5253015"/>
                <a:gd name="connsiteY0" fmla="*/ 6 h 1836416"/>
                <a:gd name="connsiteX1" fmla="*/ 6 w 5253015"/>
                <a:gd name="connsiteY1" fmla="*/ 6 h 1836416"/>
                <a:gd name="connsiteX2" fmla="*/ 6 w 5253015"/>
                <a:gd name="connsiteY2" fmla="*/ 1836422 h 183641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253015" h="1836416">
                  <a:moveTo>
                    <a:pt x="5253022" y="6"/>
                  </a:moveTo>
                  <a:lnTo>
                    <a:pt x="6" y="6"/>
                  </a:lnTo>
                  <a:lnTo>
                    <a:pt x="6" y="1836422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0" name="フリーフォーム 69">
              <a:extLst>
                <a:ext uri="{FF2B5EF4-FFF2-40B4-BE49-F238E27FC236}">
                  <a16:creationId xmlns:a16="http://schemas.microsoft.com/office/drawing/2014/main" id="{FB491091-3F95-A06E-2353-443FEF19A77B}"/>
                </a:ext>
              </a:extLst>
            </p:cNvPr>
            <p:cNvSpPr/>
            <p:nvPr/>
          </p:nvSpPr>
          <p:spPr>
            <a:xfrm>
              <a:off x="2065761" y="5647372"/>
              <a:ext cx="1937993" cy="918208"/>
            </a:xfrm>
            <a:custGeom>
              <a:avLst/>
              <a:gdLst>
                <a:gd name="connsiteX0" fmla="*/ 3502019 w 3502012"/>
                <a:gd name="connsiteY0" fmla="*/ 918214 h 918208"/>
                <a:gd name="connsiteX1" fmla="*/ 6 w 3502012"/>
                <a:gd name="connsiteY1" fmla="*/ 918214 h 918208"/>
                <a:gd name="connsiteX2" fmla="*/ 6 w 3502012"/>
                <a:gd name="connsiteY2" fmla="*/ 6 h 9182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502012" h="918208">
                  <a:moveTo>
                    <a:pt x="3502019" y="918214"/>
                  </a:moveTo>
                  <a:lnTo>
                    <a:pt x="6" y="918214"/>
                  </a:lnTo>
                  <a:lnTo>
                    <a:pt x="6" y="6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1" name="フリーフォーム 70">
              <a:extLst>
                <a:ext uri="{FF2B5EF4-FFF2-40B4-BE49-F238E27FC236}">
                  <a16:creationId xmlns:a16="http://schemas.microsoft.com/office/drawing/2014/main" id="{2E230E46-F446-3D28-0F67-6B3917E8FBDE}"/>
                </a:ext>
              </a:extLst>
            </p:cNvPr>
            <p:cNvSpPr/>
            <p:nvPr/>
          </p:nvSpPr>
          <p:spPr>
            <a:xfrm>
              <a:off x="3034758" y="4729164"/>
              <a:ext cx="968997" cy="918208"/>
            </a:xfrm>
            <a:custGeom>
              <a:avLst/>
              <a:gdLst>
                <a:gd name="connsiteX0" fmla="*/ 1751013 w 1751006"/>
                <a:gd name="connsiteY0" fmla="*/ 918214 h 918208"/>
                <a:gd name="connsiteX1" fmla="*/ 6 w 1751006"/>
                <a:gd name="connsiteY1" fmla="*/ 918214 h 918208"/>
                <a:gd name="connsiteX2" fmla="*/ 6 w 1751006"/>
                <a:gd name="connsiteY2" fmla="*/ 6 h 9182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51006" h="918208">
                  <a:moveTo>
                    <a:pt x="1751013" y="918214"/>
                  </a:moveTo>
                  <a:lnTo>
                    <a:pt x="6" y="918214"/>
                  </a:lnTo>
                  <a:lnTo>
                    <a:pt x="6" y="6"/>
                  </a:lnTo>
                </a:path>
              </a:pathLst>
            </a:custGeom>
            <a:noFill/>
            <a:ln w="38100" cap="rnd">
              <a:solidFill>
                <a:srgbClr val="000000"/>
              </a:solidFill>
              <a:prstDash val="solid"/>
              <a:round/>
            </a:ln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ja-JP" altLang="en-US"/>
            </a:p>
          </p:txBody>
        </p:sp>
        <p:sp>
          <p:nvSpPr>
            <p:cNvPr id="76" name="円/楕円 75">
              <a:extLst>
                <a:ext uri="{FF2B5EF4-FFF2-40B4-BE49-F238E27FC236}">
                  <a16:creationId xmlns:a16="http://schemas.microsoft.com/office/drawing/2014/main" id="{E34B9240-3FFB-694F-BD17-78D23A4C80D6}"/>
                </a:ext>
              </a:extLst>
            </p:cNvPr>
            <p:cNvSpPr/>
            <p:nvPr/>
          </p:nvSpPr>
          <p:spPr>
            <a:xfrm>
              <a:off x="1753879" y="1760815"/>
              <a:ext cx="541742" cy="405248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200"/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B802DA6D-8358-5F34-F0C8-866751C4DECB}"/>
                </a:ext>
              </a:extLst>
            </p:cNvPr>
            <p:cNvSpPr txBox="1"/>
            <p:nvPr/>
          </p:nvSpPr>
          <p:spPr>
            <a:xfrm>
              <a:off x="1783338" y="1824942"/>
              <a:ext cx="482824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altLang="ja-JP" sz="1200" dirty="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CLP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77" name="円/楕円 76">
              <a:extLst>
                <a:ext uri="{FF2B5EF4-FFF2-40B4-BE49-F238E27FC236}">
                  <a16:creationId xmlns:a16="http://schemas.microsoft.com/office/drawing/2014/main" id="{B0483DF7-89AE-0300-174A-DAE6EB2ED439}"/>
                </a:ext>
              </a:extLst>
            </p:cNvPr>
            <p:cNvSpPr/>
            <p:nvPr/>
          </p:nvSpPr>
          <p:spPr>
            <a:xfrm>
              <a:off x="1789949" y="5444748"/>
              <a:ext cx="541742" cy="405248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200"/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AFB605F6-55F6-9074-F976-A37FC7709FD7}"/>
                </a:ext>
              </a:extLst>
            </p:cNvPr>
            <p:cNvSpPr txBox="1"/>
            <p:nvPr/>
          </p:nvSpPr>
          <p:spPr>
            <a:xfrm>
              <a:off x="1797767" y="5508875"/>
              <a:ext cx="526106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altLang="ja-JP" sz="1200" dirty="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CMP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78" name="円/楕円 77">
              <a:extLst>
                <a:ext uri="{FF2B5EF4-FFF2-40B4-BE49-F238E27FC236}">
                  <a16:creationId xmlns:a16="http://schemas.microsoft.com/office/drawing/2014/main" id="{997A8A2E-39BD-6390-9E48-1029574BD213}"/>
                </a:ext>
              </a:extLst>
            </p:cNvPr>
            <p:cNvSpPr/>
            <p:nvPr/>
          </p:nvSpPr>
          <p:spPr>
            <a:xfrm>
              <a:off x="2225407" y="4548130"/>
              <a:ext cx="541742" cy="405248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200"/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B3F7F97C-05D7-C7EB-6AAC-9872BA9513D4}"/>
                </a:ext>
              </a:extLst>
            </p:cNvPr>
            <p:cNvSpPr txBox="1"/>
            <p:nvPr/>
          </p:nvSpPr>
          <p:spPr>
            <a:xfrm>
              <a:off x="2228416" y="4612257"/>
              <a:ext cx="535724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altLang="ja-JP" sz="1200" dirty="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GMP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79" name="円/楕円 78">
              <a:extLst>
                <a:ext uri="{FF2B5EF4-FFF2-40B4-BE49-F238E27FC236}">
                  <a16:creationId xmlns:a16="http://schemas.microsoft.com/office/drawing/2014/main" id="{0EDB960F-C979-C6EF-8C29-D89BC734AB49}"/>
                </a:ext>
              </a:extLst>
            </p:cNvPr>
            <p:cNvSpPr/>
            <p:nvPr/>
          </p:nvSpPr>
          <p:spPr>
            <a:xfrm>
              <a:off x="2740221" y="6420923"/>
              <a:ext cx="541742" cy="405248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200"/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63109C76-91CD-8FB8-35B7-530975810E13}"/>
                </a:ext>
              </a:extLst>
            </p:cNvPr>
            <p:cNvSpPr txBox="1"/>
            <p:nvPr/>
          </p:nvSpPr>
          <p:spPr>
            <a:xfrm>
              <a:off x="2752049" y="6485050"/>
              <a:ext cx="518091" cy="276999"/>
            </a:xfrm>
            <a:prstGeom prst="rect">
              <a:avLst/>
            </a:prstGeom>
            <a:noFill/>
            <a:ln w="38100">
              <a:noFill/>
            </a:ln>
          </p:spPr>
          <p:txBody>
  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pPr algn="l"/>
              <a:r>
                <a:rPr lang="en-US" altLang="ja-JP" sz="1200" dirty="0">
                  <a:ln/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  <a:sym typeface="Arial"/>
                  <a:rtl val="0"/>
                </a:rPr>
                <a:t>MEP</a:t>
              </a:r>
              <a:endParaRPr lang="ja-JP" altLang="en-US" sz="120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4007630C-9E8C-FBFE-C929-FDAD30D94312}"/>
                </a:ext>
              </a:extLst>
            </p:cNvPr>
            <p:cNvSpPr txBox="1"/>
            <p:nvPr/>
          </p:nvSpPr>
          <p:spPr>
            <a:xfrm>
              <a:off x="1162756" y="3680497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PU.1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61CF3C95-5A40-E24D-A3A1-0E944F62A79E}"/>
                </a:ext>
              </a:extLst>
            </p:cNvPr>
            <p:cNvCxnSpPr>
              <a:cxnSpLocks/>
              <a:endCxn id="65" idx="2"/>
            </p:cNvCxnSpPr>
            <p:nvPr/>
          </p:nvCxnSpPr>
          <p:spPr>
            <a:xfrm>
              <a:off x="507407" y="3810962"/>
              <a:ext cx="390527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A4B4DCB8-B61E-D8B8-F849-B0C2D5CFBE49}"/>
              </a:ext>
            </a:extLst>
          </p:cNvPr>
          <p:cNvGrpSpPr/>
          <p:nvPr/>
        </p:nvGrpSpPr>
        <p:grpSpPr>
          <a:xfrm>
            <a:off x="5087284" y="496479"/>
            <a:ext cx="8116653" cy="4489595"/>
            <a:chOff x="5087284" y="1076583"/>
            <a:chExt cx="8116653" cy="4489595"/>
          </a:xfrm>
        </p:grpSpPr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C08CE0A4-4D83-E78D-BD29-1E864EA9F03A}"/>
                </a:ext>
              </a:extLst>
            </p:cNvPr>
            <p:cNvGrpSpPr/>
            <p:nvPr/>
          </p:nvGrpSpPr>
          <p:grpSpPr>
            <a:xfrm>
              <a:off x="5306057" y="1076583"/>
              <a:ext cx="7897880" cy="4489595"/>
              <a:chOff x="2698981" y="1109748"/>
              <a:chExt cx="7904702" cy="4493473"/>
            </a:xfrm>
          </p:grpSpPr>
          <p:pic>
            <p:nvPicPr>
              <p:cNvPr id="2" name="図 1">
                <a:extLst>
                  <a:ext uri="{FF2B5EF4-FFF2-40B4-BE49-F238E27FC236}">
                    <a16:creationId xmlns:a16="http://schemas.microsoft.com/office/drawing/2014/main" id="{910CF0A6-0B52-7DEF-EFCA-DA1C145821B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-1" r="-115"/>
              <a:stretch/>
            </p:blipFill>
            <p:spPr>
              <a:xfrm>
                <a:off x="2774156" y="1601146"/>
                <a:ext cx="7772400" cy="3655708"/>
              </a:xfrm>
              <a:prstGeom prst="rect">
                <a:avLst/>
              </a:prstGeom>
            </p:spPr>
          </p:pic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DAA34FF2-90A4-F2C6-A834-28E381C92035}"/>
                  </a:ext>
                </a:extLst>
              </p:cNvPr>
              <p:cNvSpPr/>
              <p:nvPr/>
            </p:nvSpPr>
            <p:spPr>
              <a:xfrm>
                <a:off x="10530440" y="1109748"/>
                <a:ext cx="73243" cy="449347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B9D26E4B-703D-56FF-FCF5-B7F4743B6FC6}"/>
                  </a:ext>
                </a:extLst>
              </p:cNvPr>
              <p:cNvSpPr/>
              <p:nvPr/>
            </p:nvSpPr>
            <p:spPr>
              <a:xfrm rot="16200000">
                <a:off x="6599220" y="1343661"/>
                <a:ext cx="53013" cy="785349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33D88030-4162-17C7-5082-0658EE5F7FB6}"/>
                </a:ext>
              </a:extLst>
            </p:cNvPr>
            <p:cNvSpPr txBox="1"/>
            <p:nvPr/>
          </p:nvSpPr>
          <p:spPr>
            <a:xfrm>
              <a:off x="5087284" y="1753475"/>
              <a:ext cx="312906" cy="3872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250"/>
                </a:lnSpc>
              </a:pPr>
              <a:r>
                <a:rPr lang="en-US" altLang="ja-JP" sz="2000" dirty="0"/>
                <a:t>*</a:t>
              </a: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C04D7445-AB59-4BCC-1B22-C34BE6CA00BA}"/>
                </a:ext>
              </a:extLst>
            </p:cNvPr>
            <p:cNvSpPr txBox="1"/>
            <p:nvPr/>
          </p:nvSpPr>
          <p:spPr>
            <a:xfrm>
              <a:off x="5087284" y="2045921"/>
              <a:ext cx="312906" cy="3872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250"/>
                </a:lnSpc>
              </a:pPr>
              <a:r>
                <a:rPr lang="en-US" altLang="ja-JP" sz="2000" dirty="0"/>
                <a:t>*</a:t>
              </a: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A1F2D272-DBFB-FF50-AE72-5B3E0DE13759}"/>
                </a:ext>
              </a:extLst>
            </p:cNvPr>
            <p:cNvSpPr txBox="1"/>
            <p:nvPr/>
          </p:nvSpPr>
          <p:spPr>
            <a:xfrm>
              <a:off x="5087284" y="3186031"/>
              <a:ext cx="312906" cy="3872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250"/>
                </a:lnSpc>
              </a:pPr>
              <a:r>
                <a:rPr lang="en-US" altLang="ja-JP" sz="2000" dirty="0"/>
                <a:t>*</a:t>
              </a: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5932AA5B-7157-E534-C380-6B888686DE13}"/>
                </a:ext>
              </a:extLst>
            </p:cNvPr>
            <p:cNvSpPr txBox="1"/>
            <p:nvPr/>
          </p:nvSpPr>
          <p:spPr>
            <a:xfrm>
              <a:off x="5087284" y="4643889"/>
              <a:ext cx="312906" cy="3872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2250"/>
                </a:lnSpc>
              </a:pPr>
              <a:r>
                <a:rPr lang="en-US" altLang="ja-JP" sz="2000" dirty="0"/>
                <a:t>*</a:t>
              </a:r>
            </a:p>
          </p:txBody>
        </p:sp>
      </p:grp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8C96A37F-2838-6B43-226B-48F8C8D32C24}"/>
              </a:ext>
            </a:extLst>
          </p:cNvPr>
          <p:cNvSpPr txBox="1"/>
          <p:nvPr/>
        </p:nvSpPr>
        <p:spPr>
          <a:xfrm>
            <a:off x="5381167" y="5285218"/>
            <a:ext cx="7493877" cy="1000274"/>
          </a:xfrm>
          <a:prstGeom prst="rect">
            <a:avLst/>
          </a:prstGeom>
          <a:noFill/>
          <a:ln w="25400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 S5. DNA motifs enriched in the region with the change from open to closed chromatin in the lineage from LSK to CMP.</a:t>
            </a:r>
          </a:p>
          <a:p>
            <a:pPr>
              <a:spcBef>
                <a:spcPts val="600"/>
              </a:spcBef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(A) Hematopoietic differentiation and transcription factors regulating each cell lineage (modified from Lara-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Astiaso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et al. 2014, [24]). Transcription factors whose motifs were found enriched are highlighted. (B) The results of DNA motif discovery. TFs appeared in (A) are marked with asterisks.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7AF35BE-6D94-ACFB-D202-67587AD5DD77}"/>
              </a:ext>
            </a:extLst>
          </p:cNvPr>
          <p:cNvSpPr txBox="1"/>
          <p:nvPr/>
        </p:nvSpPr>
        <p:spPr>
          <a:xfrm>
            <a:off x="16296" y="70149"/>
            <a:ext cx="423514" cy="307777"/>
          </a:xfrm>
          <a:prstGeom prst="rect">
            <a:avLst/>
          </a:prstGeom>
          <a:noFill/>
          <a:ln w="25400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353FFB3-3405-DE6A-59F9-A8FC03E8AC9F}"/>
              </a:ext>
            </a:extLst>
          </p:cNvPr>
          <p:cNvSpPr txBox="1"/>
          <p:nvPr/>
        </p:nvSpPr>
        <p:spPr>
          <a:xfrm>
            <a:off x="5162796" y="70149"/>
            <a:ext cx="423514" cy="307777"/>
          </a:xfrm>
          <a:prstGeom prst="rect">
            <a:avLst/>
          </a:prstGeom>
          <a:noFill/>
          <a:ln w="25400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円/楕円 8">
            <a:extLst>
              <a:ext uri="{FF2B5EF4-FFF2-40B4-BE49-F238E27FC236}">
                <a16:creationId xmlns:a16="http://schemas.microsoft.com/office/drawing/2014/main" id="{8443EE1C-D1F6-B1CC-EB1C-0D158049392E}"/>
              </a:ext>
            </a:extLst>
          </p:cNvPr>
          <p:cNvSpPr/>
          <p:nvPr/>
        </p:nvSpPr>
        <p:spPr>
          <a:xfrm>
            <a:off x="261744" y="3561440"/>
            <a:ext cx="541742" cy="405248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9CBAE62-151E-87EA-A3A0-A02291CE7972}"/>
              </a:ext>
            </a:extLst>
          </p:cNvPr>
          <p:cNvSpPr txBox="1"/>
          <p:nvPr/>
        </p:nvSpPr>
        <p:spPr>
          <a:xfrm>
            <a:off x="313712" y="3614088"/>
            <a:ext cx="474810" cy="276999"/>
          </a:xfrm>
          <a:prstGeom prst="rect">
            <a:avLst/>
          </a:prstGeom>
          <a:noFill/>
          <a:ln w="38100">
            <a:noFill/>
          </a:ln>
        </p:spPr>
        <p:txBody>
          <a:bodyPr rot="0" spcFirstLastPara="0" vertOverflow="overflow" horzOverflow="overflow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altLang="ja-JP" sz="1200" dirty="0">
                <a:ln/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/>
                <a:rtl val="0"/>
              </a:rPr>
              <a:t>LSK</a:t>
            </a:r>
            <a:endParaRPr lang="ja-JP" altLang="en-US" sz="1200">
              <a:ln/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  <a:rtl val="0"/>
            </a:endParaRPr>
          </a:p>
        </p:txBody>
      </p:sp>
    </p:spTree>
    <p:extLst>
      <p:ext uri="{BB962C8B-B14F-4D97-AF65-F5344CB8AC3E}">
        <p14:creationId xmlns:p14="http://schemas.microsoft.com/office/powerpoint/2010/main" val="2496162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4</TotalTime>
  <Words>146</Words>
  <Application>Microsoft Macintosh PowerPoint</Application>
  <PresentationFormat>ユーザー設定</PresentationFormat>
  <Paragraphs>4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koyanag</dc:creator>
  <cp:lastModifiedBy>kkoyanag</cp:lastModifiedBy>
  <cp:revision>18</cp:revision>
  <dcterms:created xsi:type="dcterms:W3CDTF">2023-07-12T08:20:31Z</dcterms:created>
  <dcterms:modified xsi:type="dcterms:W3CDTF">2023-09-15T01:26:53Z</dcterms:modified>
</cp:coreProperties>
</file>